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24"/>
    <p:restoredTop sz="94681"/>
  </p:normalViewPr>
  <p:slideViewPr>
    <p:cSldViewPr snapToGrid="0" snapToObjects="1">
      <p:cViewPr>
        <p:scale>
          <a:sx n="210" d="100"/>
          <a:sy n="210" d="100"/>
        </p:scale>
        <p:origin x="-39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50193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16057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36751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29202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14294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73837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30302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39171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945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28435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457560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7C4AF-2375-E840-9270-CE0EBA89E912}" type="datetimeFigureOut">
              <a:rPr lang="en-DE" smtClean="0"/>
              <a:t>25.11.20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11B6A3-4B58-274B-9307-3F8CF1539766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97014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57AE0A4-4719-AE48-9FFE-C3382087F3E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4477"/>
          <a:stretch/>
        </p:blipFill>
        <p:spPr>
          <a:xfrm>
            <a:off x="-113016" y="642937"/>
            <a:ext cx="6490741" cy="557212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8765FE0-A1F5-0C46-8187-22DBB7B45D0E}"/>
              </a:ext>
            </a:extLst>
          </p:cNvPr>
          <p:cNvSpPr txBox="1"/>
          <p:nvPr/>
        </p:nvSpPr>
        <p:spPr>
          <a:xfrm>
            <a:off x="6448846" y="881422"/>
            <a:ext cx="345715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4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. Health-related quality of life during follow-up via the FACT-Hep (A./B.) </a:t>
            </a:r>
            <a:r>
              <a:rPr lang="en-DE" sz="1200">
                <a:latin typeface="Arial" panose="020B0604020202020204" pitchFamily="34" charset="0"/>
                <a:cs typeface="Arial" panose="020B0604020202020204" pitchFamily="34" charset="0"/>
              </a:rPr>
              <a:t>and EORTC 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QLQ-C30 (C./D.) </a:t>
            </a:r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A./C. 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Frequencies of quality of life assessments according to the methods sect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on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of the publications, </a:t>
            </a:r>
            <a:r>
              <a:rPr lang="en-DE" sz="1200" b="1" dirty="0">
                <a:latin typeface="Arial" panose="020B0604020202020204" pitchFamily="34" charset="0"/>
                <a:cs typeface="Arial" panose="020B0604020202020204" pitchFamily="34" charset="0"/>
              </a:rPr>
              <a:t>B./D. 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Frequencies of quality of life asssessment reported in the results part of the publications</a:t>
            </a:r>
          </a:p>
        </p:txBody>
      </p:sp>
    </p:spTree>
    <p:extLst>
      <p:ext uri="{BB962C8B-B14F-4D97-AF65-F5344CB8AC3E}">
        <p14:creationId xmlns:p14="http://schemas.microsoft.com/office/powerpoint/2010/main" val="1330304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63</Words>
  <Application>Microsoft Macintosh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 Mihaljevic</dc:creator>
  <cp:lastModifiedBy>Andre Mihaljevic</cp:lastModifiedBy>
  <cp:revision>2</cp:revision>
  <dcterms:created xsi:type="dcterms:W3CDTF">2020-11-25T05:18:54Z</dcterms:created>
  <dcterms:modified xsi:type="dcterms:W3CDTF">2020-11-25T05:24:51Z</dcterms:modified>
</cp:coreProperties>
</file>